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>
      <p:cViewPr varScale="1">
        <p:scale>
          <a:sx n="117" d="100"/>
          <a:sy n="117" d="100"/>
        </p:scale>
        <p:origin x="80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708884-0A16-4244-823E-D8E120954FC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557D05A-D510-8742-93A3-840397FA21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823A39-C5E6-1F46-A055-51ED0C226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0C7EC-EF85-1E41-A304-BC0D1111638F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6E9DBE-137B-2346-85CB-05D9A49FF3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3E724C-3F2D-5944-BFB8-1C75EE57DB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7DB5-79D6-2549-B3D8-2AF96D09E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74433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876B50-15D8-EB41-9D4D-67D9A2F1BB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271E82-BF1D-4D4E-8831-ED4E61DB4A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A44F91-CAB0-5B48-9506-6953204C29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0C7EC-EF85-1E41-A304-BC0D1111638F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409DF8-9BE8-0C41-9907-62FF64C237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C1052B-0DA4-5A45-951A-F1AAFF52A5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7DB5-79D6-2549-B3D8-2AF96D09E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5207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E098D33-7ED9-784E-9797-324413BB971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A9F93A-245D-0549-895D-BA0C088AAF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85AEDD-22CB-6146-9D63-5872394C2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0C7EC-EF85-1E41-A304-BC0D1111638F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984F73-D209-4547-8392-36FD611DF2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FA9212-5A64-DB4E-BE3D-96CA8B6284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7DB5-79D6-2549-B3D8-2AF96D09E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7418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EC2C58-DB75-C74D-91C0-28FF1E3EE4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553285-FB2D-AA43-B53E-76DFB8350D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510FD5-E65E-2E4A-B7B3-7481A9FE0D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0C7EC-EF85-1E41-A304-BC0D1111638F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8A67C4-059C-DB43-AAC5-0E56D71FD9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7FC243-D1F1-D940-9401-0FF8889994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7DB5-79D6-2549-B3D8-2AF96D09E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818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7518C2-A017-7D4B-8BB3-7AEFF506C7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EA95CBD-43DB-0D43-842D-61F69EF3E2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06BC62-1F35-2B45-A544-92AA8515DB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0C7EC-EF85-1E41-A304-BC0D1111638F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32D585-B55A-BE4F-8252-A671710496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1206FD-830D-EA44-8BC9-78ED7D26A6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7DB5-79D6-2549-B3D8-2AF96D09E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4413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11ABCB-CA5B-9D42-B483-781A905B40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DF1358-A904-E94C-B57F-A7CB317AE4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FC04D7-2839-6549-8E7F-B7E1838895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BCAFBC-6449-5E46-B36E-2C08762E39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0C7EC-EF85-1E41-A304-BC0D1111638F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8F3845-DCAF-544E-B637-E693622F75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B5E119-467E-EA44-AFC7-A0CBB2B0EB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7DB5-79D6-2549-B3D8-2AF96D09E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0049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087445-4363-844C-949B-6F403C977A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4C17F4-09F6-924B-B43E-9976CCBA04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9A9C322-FA99-8541-9AFE-3A3C8D1845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F369A8C-D068-BA49-9630-F117CFF582E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CCD4A59-1EEC-7F4C-8E39-14EBADA1BBF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9223E4B-F12A-E94A-856F-334E50257C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0C7EC-EF85-1E41-A304-BC0D1111638F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80C162A-D400-0F45-9ABC-EC70EEDC4E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9DA780E-AB1E-414B-8F11-A6F6A77534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7DB5-79D6-2549-B3D8-2AF96D09E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123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19D4FE-3751-E346-98AB-F940D0649A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1764DA2-48DA-3340-B3B1-F92F1CC9A0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0C7EC-EF85-1E41-A304-BC0D1111638F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2A0DE2F-892A-414B-9FDB-FBD229F64A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643D97-9578-C24D-9182-4636DAED74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7DB5-79D6-2549-B3D8-2AF96D09E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7754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B2E651A-1C4A-2B43-ACF8-3ECB690046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0C7EC-EF85-1E41-A304-BC0D1111638F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FA31E9F-3558-DF48-9705-8BAE63105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8CCBDA4-1572-7749-9DAC-68289E7498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7DB5-79D6-2549-B3D8-2AF96D09E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7334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A26578-5B7E-D244-B86C-847A0C9A8D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5B5493-1160-724E-9482-8990CED2C4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150E33-01D0-DC4E-B7B1-A84E1B6460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32CC11-ED0A-004E-8479-6C6B740C25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0C7EC-EF85-1E41-A304-BC0D1111638F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B96FF7-620C-8048-B25B-0D6D1290E9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1D6F43-3F91-3144-82FA-631D77C548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7DB5-79D6-2549-B3D8-2AF96D09E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3423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18CE49-70A3-4547-8D68-A751CAE0F7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1E90476-C0B5-E34F-BEF1-05F86B6F5AB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A33124-D59C-CE41-8202-ACD276B021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68158E-2A3A-F84D-80AC-8E9A78041E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0C7EC-EF85-1E41-A304-BC0D1111638F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5DFE1A-23AD-D145-A38E-B7DB413594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79FF31-9AC8-CA43-B969-DCD214DC94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87DB5-79D6-2549-B3D8-2AF96D09E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93263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126552C-3A7E-A64A-9C55-84D25BE40F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86F0AE-9F2A-0B41-8AC3-6340FB8A26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D18E5A-3A68-D442-9E97-6DF11221DB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50C7EC-EF85-1E41-A304-BC0D1111638F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58978B-9F20-0E4D-9506-B5A298E028F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F14605-F6A9-E04E-9352-91A11D42656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87DB5-79D6-2549-B3D8-2AF96D09E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085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EA58087-5C7F-4948-8F53-6AAF92F0B4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65812" y="621212"/>
            <a:ext cx="8077200" cy="5842000"/>
          </a:xfrm>
          <a:prstGeom prst="rect">
            <a:avLst/>
          </a:prstGeom>
        </p:spPr>
      </p:pic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4AD7893A-8B5D-1B45-86EB-FA4D39CA5D48}"/>
              </a:ext>
            </a:extLst>
          </p:cNvPr>
          <p:cNvCxnSpPr>
            <a:cxnSpLocks/>
          </p:cNvCxnSpPr>
          <p:nvPr/>
        </p:nvCxnSpPr>
        <p:spPr>
          <a:xfrm>
            <a:off x="1672046" y="2882537"/>
            <a:ext cx="1611085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CAC8888C-7CB2-CF4B-ABE6-19942B8A9013}"/>
              </a:ext>
            </a:extLst>
          </p:cNvPr>
          <p:cNvSpPr txBox="1"/>
          <p:nvPr/>
        </p:nvSpPr>
        <p:spPr>
          <a:xfrm>
            <a:off x="-30538" y="2697871"/>
            <a:ext cx="20954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LS-RNAseH1-V5</a:t>
            </a:r>
          </a:p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~31.4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9D75949-C217-A84A-AF8E-5C4A4F437D6A}"/>
              </a:ext>
            </a:extLst>
          </p:cNvPr>
          <p:cNvSpPr txBox="1"/>
          <p:nvPr/>
        </p:nvSpPr>
        <p:spPr>
          <a:xfrm rot="16200000">
            <a:off x="4066604" y="494636"/>
            <a:ext cx="1223412" cy="20774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4500"/>
              </a:spcAft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0% Input</a:t>
            </a:r>
          </a:p>
          <a:p>
            <a:pPr>
              <a:spcAft>
                <a:spcPts val="4500"/>
              </a:spcAft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V5 IP</a:t>
            </a:r>
          </a:p>
          <a:p>
            <a:pPr>
              <a:spcAft>
                <a:spcPts val="4500"/>
              </a:spcAft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gG I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CD82866-3086-BD47-B0B2-9B64E315244C}"/>
              </a:ext>
            </a:extLst>
          </p:cNvPr>
          <p:cNvSpPr txBox="1"/>
          <p:nvPr/>
        </p:nvSpPr>
        <p:spPr>
          <a:xfrm rot="16200000">
            <a:off x="7149017" y="494635"/>
            <a:ext cx="1223412" cy="20774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4500"/>
              </a:spcAft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0% Input</a:t>
            </a:r>
          </a:p>
          <a:p>
            <a:pPr>
              <a:spcAft>
                <a:spcPts val="4500"/>
              </a:spcAft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V5 IP</a:t>
            </a:r>
          </a:p>
          <a:p>
            <a:pPr>
              <a:spcAft>
                <a:spcPts val="4500"/>
              </a:spcAft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gG IP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828A724B-B090-784A-8861-DA7F698F7397}"/>
              </a:ext>
            </a:extLst>
          </p:cNvPr>
          <p:cNvCxnSpPr/>
          <p:nvPr/>
        </p:nvCxnSpPr>
        <p:spPr>
          <a:xfrm>
            <a:off x="3716594" y="894735"/>
            <a:ext cx="218781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99AA050C-38C0-4E45-ABF0-EE5BD862D47F}"/>
              </a:ext>
            </a:extLst>
          </p:cNvPr>
          <p:cNvCxnSpPr/>
          <p:nvPr/>
        </p:nvCxnSpPr>
        <p:spPr>
          <a:xfrm>
            <a:off x="6721977" y="889818"/>
            <a:ext cx="218781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806EF997-20F8-F344-8CB1-CF56DDB7E87F}"/>
              </a:ext>
            </a:extLst>
          </p:cNvPr>
          <p:cNvSpPr txBox="1"/>
          <p:nvPr/>
        </p:nvSpPr>
        <p:spPr>
          <a:xfrm>
            <a:off x="4359098" y="490293"/>
            <a:ext cx="9028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210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C81504D-6F26-9C41-AC74-CE5228D5859C}"/>
              </a:ext>
            </a:extLst>
          </p:cNvPr>
          <p:cNvSpPr txBox="1"/>
          <p:nvPr/>
        </p:nvSpPr>
        <p:spPr>
          <a:xfrm>
            <a:off x="7377304" y="490293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KK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B9BE57F-623B-C94D-B615-77CA75A028D3}"/>
              </a:ext>
            </a:extLst>
          </p:cNvPr>
          <p:cNvSpPr txBox="1"/>
          <p:nvPr/>
        </p:nvSpPr>
        <p:spPr>
          <a:xfrm>
            <a:off x="-34672" y="120961"/>
            <a:ext cx="18347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EK-293T Cell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A56A6A3-93A3-FB46-9405-25130EAC6AC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5520"/>
          <a:stretch/>
        </p:blipFill>
        <p:spPr>
          <a:xfrm>
            <a:off x="10326188" y="1746250"/>
            <a:ext cx="1064079" cy="3365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41274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EA58087-5C7F-4948-8F53-6AAF92F0B4F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450" t="6184" r="47629" b="31663"/>
          <a:stretch/>
        </p:blipFill>
        <p:spPr>
          <a:xfrm>
            <a:off x="2144486" y="859625"/>
            <a:ext cx="3951514" cy="3712375"/>
          </a:xfrm>
          <a:prstGeom prst="rect">
            <a:avLst/>
          </a:prstGeom>
        </p:spPr>
      </p:pic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4AD7893A-8B5D-1B45-86EB-FA4D39CA5D48}"/>
              </a:ext>
            </a:extLst>
          </p:cNvPr>
          <p:cNvCxnSpPr>
            <a:cxnSpLocks/>
          </p:cNvCxnSpPr>
          <p:nvPr/>
        </p:nvCxnSpPr>
        <p:spPr>
          <a:xfrm>
            <a:off x="1672046" y="2882537"/>
            <a:ext cx="1611085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CAC8888C-7CB2-CF4B-ABE6-19942B8A9013}"/>
              </a:ext>
            </a:extLst>
          </p:cNvPr>
          <p:cNvSpPr txBox="1"/>
          <p:nvPr/>
        </p:nvSpPr>
        <p:spPr>
          <a:xfrm>
            <a:off x="-423399" y="2697871"/>
            <a:ext cx="20954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LS-RNAseH1-V5</a:t>
            </a:r>
          </a:p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~31.4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9D75949-C217-A84A-AF8E-5C4A4F437D6A}"/>
              </a:ext>
            </a:extLst>
          </p:cNvPr>
          <p:cNvSpPr txBox="1"/>
          <p:nvPr/>
        </p:nvSpPr>
        <p:spPr>
          <a:xfrm rot="16200000">
            <a:off x="4066604" y="494636"/>
            <a:ext cx="1223412" cy="20774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4500"/>
              </a:spcAft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0% Input</a:t>
            </a:r>
          </a:p>
          <a:p>
            <a:pPr>
              <a:spcAft>
                <a:spcPts val="4500"/>
              </a:spcAft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V5 IP</a:t>
            </a:r>
          </a:p>
          <a:p>
            <a:pPr>
              <a:spcAft>
                <a:spcPts val="4500"/>
              </a:spcAft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gG IP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828A724B-B090-784A-8861-DA7F698F7397}"/>
              </a:ext>
            </a:extLst>
          </p:cNvPr>
          <p:cNvCxnSpPr/>
          <p:nvPr/>
        </p:nvCxnSpPr>
        <p:spPr>
          <a:xfrm>
            <a:off x="3716594" y="894735"/>
            <a:ext cx="218781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806EF997-20F8-F344-8CB1-CF56DDB7E87F}"/>
              </a:ext>
            </a:extLst>
          </p:cNvPr>
          <p:cNvSpPr txBox="1"/>
          <p:nvPr/>
        </p:nvSpPr>
        <p:spPr>
          <a:xfrm>
            <a:off x="4359098" y="490293"/>
            <a:ext cx="9028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210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B9BE57F-623B-C94D-B615-77CA75A028D3}"/>
              </a:ext>
            </a:extLst>
          </p:cNvPr>
          <p:cNvSpPr txBox="1"/>
          <p:nvPr/>
        </p:nvSpPr>
        <p:spPr>
          <a:xfrm>
            <a:off x="-34672" y="120961"/>
            <a:ext cx="18347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EK-293T Cells</a:t>
            </a:r>
          </a:p>
        </p:txBody>
      </p:sp>
    </p:spTree>
    <p:extLst>
      <p:ext uri="{BB962C8B-B14F-4D97-AF65-F5344CB8AC3E}">
        <p14:creationId xmlns:p14="http://schemas.microsoft.com/office/powerpoint/2010/main" val="19119256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36</Words>
  <Application>Microsoft Macintosh PowerPoint</Application>
  <PresentationFormat>Widescreen</PresentationFormat>
  <Paragraphs>1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ake Edwards</dc:creator>
  <cp:lastModifiedBy>Drake Edwards</cp:lastModifiedBy>
  <cp:revision>3</cp:revision>
  <dcterms:created xsi:type="dcterms:W3CDTF">2018-06-26T20:59:37Z</dcterms:created>
  <dcterms:modified xsi:type="dcterms:W3CDTF">2019-11-24T21:51:44Z</dcterms:modified>
</cp:coreProperties>
</file>